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348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987824" y="0"/>
            <a:ext cx="3456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Figure 2e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683568" y="404664"/>
            <a:ext cx="8028384" cy="6237011"/>
            <a:chOff x="683568" y="404664"/>
            <a:chExt cx="8028384" cy="6237011"/>
          </a:xfrm>
        </p:grpSpPr>
        <p:grpSp>
          <p:nvGrpSpPr>
            <p:cNvPr id="7" name="组合 6"/>
            <p:cNvGrpSpPr/>
            <p:nvPr/>
          </p:nvGrpSpPr>
          <p:grpSpPr>
            <a:xfrm>
              <a:off x="683568" y="404664"/>
              <a:ext cx="8028384" cy="5352256"/>
              <a:chOff x="611560" y="1052736"/>
              <a:chExt cx="8028384" cy="5352256"/>
            </a:xfrm>
          </p:grpSpPr>
          <p:pic>
            <p:nvPicPr>
              <p:cNvPr id="4" name="图片 3" descr="IMG_9376.JPG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611560" y="1052736"/>
                <a:ext cx="8028384" cy="5352256"/>
              </a:xfrm>
              <a:prstGeom prst="rect">
                <a:avLst/>
              </a:prstGeom>
            </p:spPr>
          </p:pic>
          <p:sp>
            <p:nvSpPr>
              <p:cNvPr id="6" name="矩形 5"/>
              <p:cNvSpPr/>
              <p:nvPr/>
            </p:nvSpPr>
            <p:spPr>
              <a:xfrm>
                <a:off x="1115616" y="1124744"/>
                <a:ext cx="6552728" cy="5256584"/>
              </a:xfrm>
              <a:prstGeom prst="rect">
                <a:avLst/>
              </a:prstGeom>
              <a:noFill/>
              <a:ln w="508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1571020" y="6066756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178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组合 194"/>
            <p:cNvGrpSpPr/>
            <p:nvPr/>
          </p:nvGrpSpPr>
          <p:grpSpPr>
            <a:xfrm>
              <a:off x="2483039" y="5949280"/>
              <a:ext cx="2466113" cy="692395"/>
              <a:chOff x="4100364" y="13488441"/>
              <a:chExt cx="2466113" cy="692395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5198683" y="13842282"/>
                <a:ext cx="7920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-1</a:t>
                </a:r>
                <a:endParaRPr lang="zh-CN" alt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52"/>
              <p:cNvSpPr txBox="1"/>
              <p:nvPr/>
            </p:nvSpPr>
            <p:spPr>
              <a:xfrm>
                <a:off x="4100364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52"/>
              <p:cNvSpPr txBox="1"/>
              <p:nvPr/>
            </p:nvSpPr>
            <p:spPr>
              <a:xfrm>
                <a:off x="57379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直接连接符 12"/>
              <p:cNvCxnSpPr/>
              <p:nvPr/>
            </p:nvCxnSpPr>
            <p:spPr>
              <a:xfrm>
                <a:off x="4598817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4" name="组合 194"/>
            <p:cNvGrpSpPr/>
            <p:nvPr/>
          </p:nvGrpSpPr>
          <p:grpSpPr>
            <a:xfrm>
              <a:off x="4984002" y="5947676"/>
              <a:ext cx="2446863" cy="692395"/>
              <a:chOff x="4119614" y="13488441"/>
              <a:chExt cx="2446863" cy="692395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5198683" y="13842282"/>
                <a:ext cx="7920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-2</a:t>
                </a:r>
                <a:endParaRPr lang="zh-CN" alt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52"/>
              <p:cNvSpPr txBox="1"/>
              <p:nvPr/>
            </p:nvSpPr>
            <p:spPr>
              <a:xfrm>
                <a:off x="4119614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52"/>
              <p:cNvSpPr txBox="1"/>
              <p:nvPr/>
            </p:nvSpPr>
            <p:spPr>
              <a:xfrm>
                <a:off x="57379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接连接符 17"/>
              <p:cNvCxnSpPr/>
              <p:nvPr/>
            </p:nvCxnSpPr>
            <p:spPr>
              <a:xfrm>
                <a:off x="4598817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987824" y="0"/>
            <a:ext cx="3456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Figure 2e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396044" y="404664"/>
            <a:ext cx="8568444" cy="6453336"/>
            <a:chOff x="396044" y="404664"/>
            <a:chExt cx="8568444" cy="6453336"/>
          </a:xfrm>
        </p:grpSpPr>
        <p:pic>
          <p:nvPicPr>
            <p:cNvPr id="4" name="图片 3" descr="IMG_9489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96044" y="404664"/>
              <a:ext cx="8568444" cy="5712296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827584" y="692696"/>
              <a:ext cx="6984776" cy="5400600"/>
            </a:xfrm>
            <a:prstGeom prst="rect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722124" y="6285505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178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组合 194"/>
            <p:cNvGrpSpPr/>
            <p:nvPr/>
          </p:nvGrpSpPr>
          <p:grpSpPr>
            <a:xfrm>
              <a:off x="2615294" y="6165605"/>
              <a:ext cx="2244738" cy="692395"/>
              <a:chOff x="4090739" y="13488441"/>
              <a:chExt cx="2244738" cy="692395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4463269" y="13842282"/>
                <a:ext cx="152750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-3</a:t>
                </a:r>
                <a:endParaRPr lang="zh-CN" alt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52"/>
              <p:cNvSpPr txBox="1"/>
              <p:nvPr/>
            </p:nvSpPr>
            <p:spPr>
              <a:xfrm>
                <a:off x="4090739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52"/>
              <p:cNvSpPr txBox="1"/>
              <p:nvPr/>
            </p:nvSpPr>
            <p:spPr>
              <a:xfrm>
                <a:off x="55069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" name="直接连接符 11"/>
              <p:cNvCxnSpPr/>
              <p:nvPr/>
            </p:nvCxnSpPr>
            <p:spPr>
              <a:xfrm>
                <a:off x="4454442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3" name="组合 194"/>
            <p:cNvGrpSpPr/>
            <p:nvPr/>
          </p:nvGrpSpPr>
          <p:grpSpPr>
            <a:xfrm>
              <a:off x="5149832" y="6165605"/>
              <a:ext cx="2302488" cy="692395"/>
              <a:chOff x="3955989" y="13488441"/>
              <a:chExt cx="2302488" cy="692395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4386269" y="13842282"/>
                <a:ext cx="160450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-4</a:t>
                </a:r>
                <a:endParaRPr lang="zh-CN" alt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52"/>
              <p:cNvSpPr txBox="1"/>
              <p:nvPr/>
            </p:nvSpPr>
            <p:spPr>
              <a:xfrm>
                <a:off x="3955989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52"/>
              <p:cNvSpPr txBox="1"/>
              <p:nvPr/>
            </p:nvSpPr>
            <p:spPr>
              <a:xfrm>
                <a:off x="54299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直接连接符 16"/>
              <p:cNvCxnSpPr/>
              <p:nvPr/>
            </p:nvCxnSpPr>
            <p:spPr>
              <a:xfrm>
                <a:off x="4377442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323527" y="671914"/>
            <a:ext cx="8208913" cy="6257793"/>
            <a:chOff x="323527" y="671914"/>
            <a:chExt cx="8208913" cy="6257793"/>
          </a:xfrm>
        </p:grpSpPr>
        <p:pic>
          <p:nvPicPr>
            <p:cNvPr id="2" name="图片 1" descr="IMG_9391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23527" y="671914"/>
              <a:ext cx="8208913" cy="5472608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>
              <a:off x="1187624" y="764704"/>
              <a:ext cx="6552728" cy="5256584"/>
            </a:xfrm>
            <a:prstGeom prst="rect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571020" y="6354788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178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563888" y="6591153"/>
              <a:ext cx="7920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-1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2"/>
            <p:cNvSpPr txBox="1"/>
            <p:nvPr/>
          </p:nvSpPr>
          <p:spPr>
            <a:xfrm>
              <a:off x="2483039" y="6237312"/>
              <a:ext cx="16326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Non-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52"/>
            <p:cNvSpPr txBox="1"/>
            <p:nvPr/>
          </p:nvSpPr>
          <p:spPr>
            <a:xfrm>
              <a:off x="4120651" y="6237312"/>
              <a:ext cx="8285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7"/>
            <p:cNvCxnSpPr/>
            <p:nvPr/>
          </p:nvCxnSpPr>
          <p:spPr>
            <a:xfrm>
              <a:off x="2981492" y="6601544"/>
              <a:ext cx="1584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9" name="TextBox 8"/>
            <p:cNvSpPr txBox="1"/>
            <p:nvPr/>
          </p:nvSpPr>
          <p:spPr>
            <a:xfrm>
              <a:off x="6012160" y="6589549"/>
              <a:ext cx="7920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-2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52"/>
            <p:cNvSpPr txBox="1"/>
            <p:nvPr/>
          </p:nvSpPr>
          <p:spPr>
            <a:xfrm>
              <a:off x="4984002" y="6235708"/>
              <a:ext cx="16326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Non-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52"/>
            <p:cNvSpPr txBox="1"/>
            <p:nvPr/>
          </p:nvSpPr>
          <p:spPr>
            <a:xfrm>
              <a:off x="6602364" y="6235708"/>
              <a:ext cx="8285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5463205" y="6599940"/>
              <a:ext cx="1584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13" name="TextBox 12"/>
          <p:cNvSpPr txBox="1"/>
          <p:nvPr/>
        </p:nvSpPr>
        <p:spPr>
          <a:xfrm>
            <a:off x="2987824" y="0"/>
            <a:ext cx="3456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Figure 2e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396044" y="496725"/>
            <a:ext cx="8568444" cy="6460667"/>
            <a:chOff x="396044" y="496725"/>
            <a:chExt cx="8568444" cy="6460667"/>
          </a:xfrm>
        </p:grpSpPr>
        <p:pic>
          <p:nvPicPr>
            <p:cNvPr id="2" name="图片 1" descr="IMG_9565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96044" y="496725"/>
              <a:ext cx="8568444" cy="5712296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>
              <a:off x="827584" y="792088"/>
              <a:ext cx="6984776" cy="5400600"/>
            </a:xfrm>
            <a:prstGeom prst="rect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454874" y="6384897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178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131840" y="6618838"/>
              <a:ext cx="7920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-3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2"/>
            <p:cNvSpPr txBox="1"/>
            <p:nvPr/>
          </p:nvSpPr>
          <p:spPr>
            <a:xfrm>
              <a:off x="2348044" y="6264997"/>
              <a:ext cx="16326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Non-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52"/>
            <p:cNvSpPr txBox="1"/>
            <p:nvPr/>
          </p:nvSpPr>
          <p:spPr>
            <a:xfrm>
              <a:off x="3764281" y="6264997"/>
              <a:ext cx="8285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7"/>
            <p:cNvCxnSpPr/>
            <p:nvPr/>
          </p:nvCxnSpPr>
          <p:spPr>
            <a:xfrm>
              <a:off x="2711747" y="6629229"/>
              <a:ext cx="1584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9" name="TextBox 8"/>
            <p:cNvSpPr txBox="1"/>
            <p:nvPr/>
          </p:nvSpPr>
          <p:spPr>
            <a:xfrm>
              <a:off x="6012160" y="6618838"/>
              <a:ext cx="7920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-4</a:t>
              </a:r>
              <a:endParaRPr lang="zh-CN" altLang="en-US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52"/>
            <p:cNvSpPr txBox="1"/>
            <p:nvPr/>
          </p:nvSpPr>
          <p:spPr>
            <a:xfrm>
              <a:off x="5005816" y="6264997"/>
              <a:ext cx="16326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Non-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52"/>
            <p:cNvSpPr txBox="1"/>
            <p:nvPr/>
          </p:nvSpPr>
          <p:spPr>
            <a:xfrm>
              <a:off x="6479803" y="6264997"/>
              <a:ext cx="8285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an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5427269" y="6629229"/>
              <a:ext cx="1584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13" name="TextBox 12"/>
          <p:cNvSpPr txBox="1"/>
          <p:nvPr/>
        </p:nvSpPr>
        <p:spPr>
          <a:xfrm>
            <a:off x="2987824" y="0"/>
            <a:ext cx="3456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Figure 2e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4</Words>
  <Application>Microsoft Office PowerPoint</Application>
  <PresentationFormat>全屏显示(4:3)</PresentationFormat>
  <Paragraphs>32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5</cp:revision>
  <dcterms:created xsi:type="dcterms:W3CDTF">2019-10-03T04:54:57Z</dcterms:created>
  <dcterms:modified xsi:type="dcterms:W3CDTF">2019-10-14T06:45:47Z</dcterms:modified>
</cp:coreProperties>
</file>